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308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185" autoAdjust="0"/>
    <p:restoredTop sz="94675"/>
  </p:normalViewPr>
  <p:slideViewPr>
    <p:cSldViewPr snapToGrid="0">
      <p:cViewPr varScale="1">
        <p:scale>
          <a:sx n="61" d="100"/>
          <a:sy n="61" d="100"/>
        </p:scale>
        <p:origin x="237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5BB2036-A7E7-4399-BEAD-150E454AF087}" type="datetimeFigureOut">
              <a:rPr lang="en-US" smtClean="0"/>
              <a:t>4/5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FB869E4-A2ED-4199-91A7-6968B88251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96250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35FA1-7FF2-49A7-9503-55D876636AB4}" type="datetimeFigureOut">
              <a:rPr lang="en-US" smtClean="0"/>
              <a:t>4/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A5ED9-A02D-45E9-81CC-B0B085891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49258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35FA1-7FF2-49A7-9503-55D876636AB4}" type="datetimeFigureOut">
              <a:rPr lang="en-US" smtClean="0"/>
              <a:t>4/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A5ED9-A02D-45E9-81CC-B0B085891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79829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35FA1-7FF2-49A7-9503-55D876636AB4}" type="datetimeFigureOut">
              <a:rPr lang="en-US" smtClean="0"/>
              <a:t>4/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A5ED9-A02D-45E9-81CC-B0B085891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2729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35FA1-7FF2-49A7-9503-55D876636AB4}" type="datetimeFigureOut">
              <a:rPr lang="en-US" smtClean="0"/>
              <a:t>4/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A5ED9-A02D-45E9-81CC-B0B085891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74548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35FA1-7FF2-49A7-9503-55D876636AB4}" type="datetimeFigureOut">
              <a:rPr lang="en-US" smtClean="0"/>
              <a:t>4/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A5ED9-A02D-45E9-81CC-B0B085891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95042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35FA1-7FF2-49A7-9503-55D876636AB4}" type="datetimeFigureOut">
              <a:rPr lang="en-US" smtClean="0"/>
              <a:t>4/5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A5ED9-A02D-45E9-81CC-B0B085891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5879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35FA1-7FF2-49A7-9503-55D876636AB4}" type="datetimeFigureOut">
              <a:rPr lang="en-US" smtClean="0"/>
              <a:t>4/5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A5ED9-A02D-45E9-81CC-B0B085891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21656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35FA1-7FF2-49A7-9503-55D876636AB4}" type="datetimeFigureOut">
              <a:rPr lang="en-US" smtClean="0"/>
              <a:t>4/5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A5ED9-A02D-45E9-81CC-B0B085891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17869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35FA1-7FF2-49A7-9503-55D876636AB4}" type="datetimeFigureOut">
              <a:rPr lang="en-US" smtClean="0"/>
              <a:t>4/5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A5ED9-A02D-45E9-81CC-B0B085891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62829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35FA1-7FF2-49A7-9503-55D876636AB4}" type="datetimeFigureOut">
              <a:rPr lang="en-US" smtClean="0"/>
              <a:t>4/5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A5ED9-A02D-45E9-81CC-B0B085891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18578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35FA1-7FF2-49A7-9503-55D876636AB4}" type="datetimeFigureOut">
              <a:rPr lang="en-US" smtClean="0"/>
              <a:t>4/5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A5ED9-A02D-45E9-81CC-B0B085891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58884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635FA1-7FF2-49A7-9503-55D876636AB4}" type="datetimeFigureOut">
              <a:rPr lang="en-US" smtClean="0"/>
              <a:t>4/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EA5ED9-A02D-45E9-81CC-B0B085891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56901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>
            <a:extLst>
              <a:ext uri="{FF2B5EF4-FFF2-40B4-BE49-F238E27FC236}">
                <a16:creationId xmlns:a16="http://schemas.microsoft.com/office/drawing/2014/main" id="{B64C2D6C-D7B5-4EC3-888D-43EA9AF8634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9107" y="963676"/>
            <a:ext cx="1994311" cy="1994311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A999F5C8-AFB3-4AE3-ABA6-D406CB25D2D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790" y="958472"/>
            <a:ext cx="1994311" cy="1994311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EF69F2B2-CCD2-4BCB-AEB8-7DD15C489F0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4664" y="969641"/>
            <a:ext cx="1994311" cy="1994311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6AE04039-9157-4A70-A88C-8923183B55BF}"/>
              </a:ext>
            </a:extLst>
          </p:cNvPr>
          <p:cNvSpPr txBox="1"/>
          <p:nvPr/>
        </p:nvSpPr>
        <p:spPr>
          <a:xfrm>
            <a:off x="721938" y="2958368"/>
            <a:ext cx="156805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Comparison: </a:t>
            </a:r>
            <a:r>
              <a:rPr lang="en-US" sz="800" b="1" i="1" dirty="0"/>
              <a:t>E. coli </a:t>
            </a:r>
            <a:r>
              <a:rPr lang="en-US" sz="800" b="1" dirty="0"/>
              <a:t>vs UT</a:t>
            </a:r>
          </a:p>
          <a:p>
            <a:r>
              <a:rPr lang="en-US" sz="800" b="1" dirty="0"/>
              <a:t>Enrichment score (ES): 0.412255 </a:t>
            </a:r>
          </a:p>
          <a:p>
            <a:r>
              <a:rPr lang="en-US" sz="800" b="1" dirty="0"/>
              <a:t>Normalized ES: 1.525511  </a:t>
            </a:r>
          </a:p>
          <a:p>
            <a:r>
              <a:rPr lang="en-US" sz="800" b="1" dirty="0"/>
              <a:t>Nominal p-value: 0.004505 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44119AC-D039-439B-ACF6-A1EDA6A1F1E8}"/>
              </a:ext>
            </a:extLst>
          </p:cNvPr>
          <p:cNvSpPr txBox="1"/>
          <p:nvPr/>
        </p:nvSpPr>
        <p:spPr>
          <a:xfrm>
            <a:off x="2858947" y="2956506"/>
            <a:ext cx="159050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Comparison: 5-A-RU vs UT</a:t>
            </a:r>
          </a:p>
          <a:p>
            <a:r>
              <a:rPr lang="en-US" sz="800" b="1" dirty="0"/>
              <a:t>Enrichment score (ES): 0.344806  </a:t>
            </a:r>
          </a:p>
          <a:p>
            <a:r>
              <a:rPr lang="en-US" sz="800" b="1" dirty="0"/>
              <a:t>Normalized ES: 1.1297826 </a:t>
            </a:r>
          </a:p>
          <a:p>
            <a:r>
              <a:rPr lang="en-US" sz="800" b="1" dirty="0"/>
              <a:t>Nominal p-value: 0.04024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27050F1-4413-447C-B2F9-63E94EC069ED}"/>
              </a:ext>
            </a:extLst>
          </p:cNvPr>
          <p:cNvSpPr txBox="1"/>
          <p:nvPr/>
        </p:nvSpPr>
        <p:spPr>
          <a:xfrm>
            <a:off x="4927108" y="2963952"/>
            <a:ext cx="156805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Comparison: IL-12+IL-18 vs UT</a:t>
            </a:r>
          </a:p>
          <a:p>
            <a:r>
              <a:rPr lang="en-US" sz="800" b="1" dirty="0"/>
              <a:t>Enrichment score (ES): 0.396008 </a:t>
            </a:r>
          </a:p>
          <a:p>
            <a:r>
              <a:rPr lang="en-US" sz="800" b="1" dirty="0"/>
              <a:t>Normalized ES: 1.55075 </a:t>
            </a:r>
          </a:p>
          <a:p>
            <a:r>
              <a:rPr lang="en-US" sz="800" b="1" dirty="0"/>
              <a:t>Nominal p-value:  0.00216 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8C669E69-CA23-4DFF-88EF-EEF0A4854F8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4913" y="6268035"/>
            <a:ext cx="1994309" cy="199430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1CCD2B7C-C30A-40BD-8F30-18D20CAEABE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6787" y="6268035"/>
            <a:ext cx="1994309" cy="199430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FC467230-A4AA-4CD0-83BD-DAD6B32F53DD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11228" y="6268034"/>
            <a:ext cx="1994310" cy="199431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9C3FC9B-FC9D-45A2-BD63-9541D7553C0B}"/>
              </a:ext>
            </a:extLst>
          </p:cNvPr>
          <p:cNvSpPr txBox="1"/>
          <p:nvPr/>
        </p:nvSpPr>
        <p:spPr>
          <a:xfrm>
            <a:off x="760923" y="8266067"/>
            <a:ext cx="156805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Comparison: </a:t>
            </a:r>
            <a:r>
              <a:rPr lang="en-US" sz="800" b="1" i="1" dirty="0"/>
              <a:t>E. coli </a:t>
            </a:r>
            <a:r>
              <a:rPr lang="en-US" sz="800" b="1" dirty="0"/>
              <a:t>vs UT</a:t>
            </a:r>
          </a:p>
          <a:p>
            <a:r>
              <a:rPr lang="en-US" sz="800" b="1" dirty="0"/>
              <a:t>Enrichment score (ES): 0.566279 </a:t>
            </a:r>
          </a:p>
          <a:p>
            <a:r>
              <a:rPr lang="en-US" sz="800" b="1" dirty="0"/>
              <a:t>Normalized ES: 1.829919  </a:t>
            </a:r>
          </a:p>
          <a:p>
            <a:r>
              <a:rPr lang="en-US" sz="800" b="1" dirty="0"/>
              <a:t>Nominal p-value: &lt; 0.001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470EBF2-1319-4CD7-A065-8F196173A2D5}"/>
              </a:ext>
            </a:extLst>
          </p:cNvPr>
          <p:cNvSpPr txBox="1"/>
          <p:nvPr/>
        </p:nvSpPr>
        <p:spPr>
          <a:xfrm>
            <a:off x="2880472" y="8262344"/>
            <a:ext cx="159050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Comparison: 5-A-RU vs UT</a:t>
            </a:r>
          </a:p>
          <a:p>
            <a:r>
              <a:rPr lang="en-US" sz="800" b="1" dirty="0"/>
              <a:t>Enrichment score (ES): 0.583159  </a:t>
            </a:r>
          </a:p>
          <a:p>
            <a:r>
              <a:rPr lang="en-US" sz="800" b="1" dirty="0"/>
              <a:t>Normalized ES: 1.90212  </a:t>
            </a:r>
          </a:p>
          <a:p>
            <a:r>
              <a:rPr lang="en-US" sz="800" b="1" dirty="0"/>
              <a:t>Nominal p-value: &lt; 0.001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E40375B-1CA1-4473-9800-7C5DFD1F2A7F}"/>
              </a:ext>
            </a:extLst>
          </p:cNvPr>
          <p:cNvSpPr txBox="1"/>
          <p:nvPr/>
        </p:nvSpPr>
        <p:spPr>
          <a:xfrm>
            <a:off x="5002962" y="8262344"/>
            <a:ext cx="156805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Comparison: IL-12+IL-18 vs UT</a:t>
            </a:r>
          </a:p>
          <a:p>
            <a:r>
              <a:rPr lang="en-US" sz="800" b="1" dirty="0"/>
              <a:t>Enrichment score (ES): 0.381098 </a:t>
            </a:r>
          </a:p>
          <a:p>
            <a:r>
              <a:rPr lang="en-US" sz="800" b="1" dirty="0"/>
              <a:t>Normalized ES: 1.294611 </a:t>
            </a:r>
          </a:p>
          <a:p>
            <a:r>
              <a:rPr lang="en-US" sz="800" b="1" dirty="0"/>
              <a:t>Nominal p-value: 0.076 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81831824-43E2-48D4-9511-AF7C60FDF60D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9105" y="3615856"/>
            <a:ext cx="1994310" cy="199431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3D6DAFD-5838-462F-9504-0BA4AF1A7653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7319" y="3608410"/>
            <a:ext cx="1994310" cy="199431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09E93FA7-43AA-422A-87FB-623994F8F2DD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790" y="3608410"/>
            <a:ext cx="1994310" cy="199431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53FBA60A-7A8C-4FCF-9D8A-30E0D8B83AA4}"/>
              </a:ext>
            </a:extLst>
          </p:cNvPr>
          <p:cNvSpPr txBox="1"/>
          <p:nvPr/>
        </p:nvSpPr>
        <p:spPr>
          <a:xfrm>
            <a:off x="760923" y="5610166"/>
            <a:ext cx="156805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Comparison: </a:t>
            </a:r>
            <a:r>
              <a:rPr lang="en-US" sz="800" b="1" i="1" dirty="0"/>
              <a:t>E. coli </a:t>
            </a:r>
            <a:r>
              <a:rPr lang="en-US" sz="800" b="1" dirty="0"/>
              <a:t>vs UT</a:t>
            </a:r>
          </a:p>
          <a:p>
            <a:r>
              <a:rPr lang="en-US" sz="800" b="1" dirty="0"/>
              <a:t>Enrichment score (ES): 0.493713 </a:t>
            </a:r>
          </a:p>
          <a:p>
            <a:r>
              <a:rPr lang="en-US" sz="800" b="1" dirty="0"/>
              <a:t>Normalized ES: 1.652987  </a:t>
            </a:r>
          </a:p>
          <a:p>
            <a:r>
              <a:rPr lang="en-US" sz="800" b="1" dirty="0"/>
              <a:t>Nominal p-value: &lt; 0.001 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867E379-84B6-4E96-A3E9-9BD91E4E9672}"/>
              </a:ext>
            </a:extLst>
          </p:cNvPr>
          <p:cNvSpPr txBox="1"/>
          <p:nvPr/>
        </p:nvSpPr>
        <p:spPr>
          <a:xfrm>
            <a:off x="2880472" y="5606443"/>
            <a:ext cx="159050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Comparison: 5-A-RU vs UT</a:t>
            </a:r>
          </a:p>
          <a:p>
            <a:r>
              <a:rPr lang="en-US" sz="800" b="1" dirty="0"/>
              <a:t>Enrichment score (ES): 0.335679  </a:t>
            </a:r>
          </a:p>
          <a:p>
            <a:r>
              <a:rPr lang="en-US" sz="800" b="1" dirty="0"/>
              <a:t>Normalized ES: 1.15455  </a:t>
            </a:r>
          </a:p>
          <a:p>
            <a:r>
              <a:rPr lang="en-US" sz="800" b="1" dirty="0"/>
              <a:t>Nominal p-value: 0.17647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D82F587-F5C9-478C-9E69-1B9BCDFB5901}"/>
              </a:ext>
            </a:extLst>
          </p:cNvPr>
          <p:cNvSpPr txBox="1"/>
          <p:nvPr/>
        </p:nvSpPr>
        <p:spPr>
          <a:xfrm>
            <a:off x="5002962" y="5606443"/>
            <a:ext cx="156805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Comparison: IL-12+IL-18 vs UT</a:t>
            </a:r>
          </a:p>
          <a:p>
            <a:r>
              <a:rPr lang="en-US" sz="800" b="1" dirty="0"/>
              <a:t>Enrichment score (ES): 0.583643 </a:t>
            </a:r>
          </a:p>
          <a:p>
            <a:r>
              <a:rPr lang="en-US" sz="800" b="1" dirty="0"/>
              <a:t>Normalized ES: 2.076548 </a:t>
            </a:r>
          </a:p>
          <a:p>
            <a:r>
              <a:rPr lang="en-US" sz="800" b="1" dirty="0"/>
              <a:t>Nominal p-value: &lt; 0.001 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704C29A-9F49-4B27-B77C-549B5C138B7E}"/>
              </a:ext>
            </a:extLst>
          </p:cNvPr>
          <p:cNvSpPr txBox="1"/>
          <p:nvPr/>
        </p:nvSpPr>
        <p:spPr>
          <a:xfrm>
            <a:off x="0" y="58689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CD0D1D2-2B24-4104-99B2-A2B7996FF0BC}"/>
              </a:ext>
            </a:extLst>
          </p:cNvPr>
          <p:cNvSpPr txBox="1"/>
          <p:nvPr/>
        </p:nvSpPr>
        <p:spPr>
          <a:xfrm>
            <a:off x="4809" y="3303877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5C3814B-B417-490E-90E7-33D2F79ADC6F}"/>
              </a:ext>
            </a:extLst>
          </p:cNvPr>
          <p:cNvSpPr txBox="1"/>
          <p:nvPr/>
        </p:nvSpPr>
        <p:spPr>
          <a:xfrm>
            <a:off x="-31585" y="5924765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ECB61A5-067A-4CCD-9351-7C10DD7D040E}"/>
              </a:ext>
            </a:extLst>
          </p:cNvPr>
          <p:cNvSpPr txBox="1"/>
          <p:nvPr/>
        </p:nvSpPr>
        <p:spPr>
          <a:xfrm>
            <a:off x="0" y="124048"/>
            <a:ext cx="1153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. Figure 2</a:t>
            </a:r>
          </a:p>
        </p:txBody>
      </p:sp>
    </p:spTree>
    <p:extLst>
      <p:ext uri="{BB962C8B-B14F-4D97-AF65-F5344CB8AC3E}">
        <p14:creationId xmlns:p14="http://schemas.microsoft.com/office/powerpoint/2010/main" val="6082699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27</TotalTime>
  <Words>194</Words>
  <Application>Microsoft Macintosh PowerPoint</Application>
  <PresentationFormat>On-screen Show (4:3)</PresentationFormat>
  <Paragraphs>4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jesh Lamichhane</dc:creator>
  <cp:lastModifiedBy>James Ussher</cp:lastModifiedBy>
  <cp:revision>512</cp:revision>
  <dcterms:created xsi:type="dcterms:W3CDTF">2017-12-08T03:20:58Z</dcterms:created>
  <dcterms:modified xsi:type="dcterms:W3CDTF">2019-04-05T02:40:35Z</dcterms:modified>
</cp:coreProperties>
</file>